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  <p:sldId id="274" r:id="rId3"/>
    <p:sldId id="276" r:id="rId4"/>
    <p:sldId id="277" r:id="rId5"/>
    <p:sldId id="278" r:id="rId6"/>
    <p:sldId id="279" r:id="rId7"/>
    <p:sldId id="280" r:id="rId8"/>
    <p:sldId id="281" r:id="rId9"/>
    <p:sldId id="282" r:id="rId10"/>
    <p:sldId id="283" r:id="rId11"/>
    <p:sldId id="284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6" d="100"/>
          <a:sy n="46" d="100"/>
        </p:scale>
        <p:origin x="2212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45406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392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1387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440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4102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5162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444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7821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126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87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7402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94CD0-DCCA-4FF6-BDEE-69FA019C3398}" type="datetimeFigureOut">
              <a:rPr lang="zh-CN" altLang="en-US" smtClean="0"/>
              <a:t>2023/7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A9040-57E5-4760-9C00-FCDFC6E931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717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E4A147-247D-321D-81B8-6F3516A715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63769" y="3632706"/>
            <a:ext cx="6330462" cy="717948"/>
          </a:xfrm>
        </p:spPr>
        <p:txBody>
          <a:bodyPr>
            <a:normAutofit fontScale="90000"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 and figure legend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3D652BE-7832-72DD-D009-14818A440D35}"/>
              </a:ext>
            </a:extLst>
          </p:cNvPr>
          <p:cNvSpPr txBox="1"/>
          <p:nvPr/>
        </p:nvSpPr>
        <p:spPr>
          <a:xfrm>
            <a:off x="230451" y="1526496"/>
            <a:ext cx="6397098" cy="4757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m</a:t>
            </a:r>
            <a:r>
              <a:rPr lang="en-US" altLang="zh-CN" sz="1246" b="1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 methyltransferase NSUN2 promotes codon-dependent oncogenic translation by sustaining tRNA stability in anaplastic thyroid cancer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3B134F5-6CE9-3C64-22CF-EE4381C7CFCB}"/>
              </a:ext>
            </a:extLst>
          </p:cNvPr>
          <p:cNvSpPr txBox="1"/>
          <p:nvPr/>
        </p:nvSpPr>
        <p:spPr>
          <a:xfrm>
            <a:off x="297087" y="2024363"/>
            <a:ext cx="4221418" cy="6370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eng Li</a:t>
            </a:r>
            <a:r>
              <a:rPr lang="en-US" altLang="zh-CN" sz="1246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#1,2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D, </a:t>
            </a:r>
            <a:r>
              <a:rPr lang="en-US" altLang="zh-CN" sz="1246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enlong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ang</a:t>
            </a:r>
            <a:r>
              <a:rPr lang="en-US" altLang="zh-CN" sz="1246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#1,2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hD</a:t>
            </a:r>
            <a:r>
              <a:rPr lang="zh-CN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，</a:t>
            </a:r>
            <a:r>
              <a:rPr lang="en-US" altLang="zh-CN" sz="1246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uixin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Zhou</a:t>
            </a:r>
            <a:r>
              <a:rPr lang="en-US" altLang="zh-CN" sz="1246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D, Ying Ding</a:t>
            </a:r>
            <a:r>
              <a:rPr lang="en-US" altLang="zh-CN" sz="1246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D, </a:t>
            </a:r>
            <a:r>
              <a:rPr lang="en-US" altLang="zh-CN" sz="1246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Xinying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i</a:t>
            </a:r>
            <a:r>
              <a:rPr lang="en-US" altLang="zh-CN" sz="1246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,2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hD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211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722A128E-9270-513D-7836-6F2C31E6D9E9}"/>
              </a:ext>
            </a:extLst>
          </p:cNvPr>
          <p:cNvSpPr txBox="1"/>
          <p:nvPr/>
        </p:nvSpPr>
        <p:spPr>
          <a:xfrm>
            <a:off x="4934140" y="9598223"/>
            <a:ext cx="1923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D5BB035-A8FC-AD3E-94D4-AD3C393895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34616"/>
            <a:ext cx="6858000" cy="7836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63592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74A2052D-0BD1-03A6-85F5-045E5CE5E215}"/>
              </a:ext>
            </a:extLst>
          </p:cNvPr>
          <p:cNvSpPr txBox="1"/>
          <p:nvPr/>
        </p:nvSpPr>
        <p:spPr>
          <a:xfrm>
            <a:off x="128239" y="186046"/>
            <a:ext cx="6601522" cy="6674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5. Puromycin intake assay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licates and statistical analysis of puromycin intake assay to monitor protein synthesis. si-1 and si-2 indicates NSUN2 knockdown using siRNA.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eNSUN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dicates NSUN2 overexpression. 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0766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185EC06-28AF-EC9E-D5FC-827512E9A875}"/>
              </a:ext>
            </a:extLst>
          </p:cNvPr>
          <p:cNvSpPr txBox="1"/>
          <p:nvPr/>
        </p:nvSpPr>
        <p:spPr>
          <a:xfrm>
            <a:off x="4934140" y="9598223"/>
            <a:ext cx="1923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CBD8CA6-1BD4-02A0-F918-F11D73D3FB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69200"/>
            <a:ext cx="6858000" cy="7767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08171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75BAF3EA-512A-10EA-2158-B7C67A1D021C}"/>
              </a:ext>
            </a:extLst>
          </p:cNvPr>
          <p:cNvSpPr txBox="1"/>
          <p:nvPr/>
        </p:nvSpPr>
        <p:spPr>
          <a:xfrm>
            <a:off x="152352" y="185333"/>
            <a:ext cx="6553296" cy="18178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1. Relative bioinformatics analysis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Violin plots showing the expression of m</a:t>
            </a:r>
            <a:r>
              <a:rPr lang="en-US" altLang="zh-CN" sz="1246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 system between ATC and PTC or normal thyroid samples from GEO datasets GSE33630, GES65144, GSE29265, GSE6004 and GSE76039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The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BioPortal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ncoPrint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ap shows the distribution of NSUN2 genome changes in thyroid cancer patients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Kaplan–Meier survival curve analysis of the prognostic significance of a high and a low expression of NSUN2 in ATC using The Cancer Genome Atlas (TCGA) database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Box plots showing the expression of NSUN2 between ATC and normal or PTC samples from pooled GEO datasets GSE33630, GES65144, GSE29265, GSE6004 and GSE76039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Pathway and process enrichment analysis of NSUN2</a:t>
            </a:r>
            <a:r>
              <a:rPr lang="en-US" altLang="zh-CN" sz="1246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igh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atients RNA-seq from TCGA data. 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102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2598F90-872F-6FCD-0375-C1F5C470BA64}"/>
              </a:ext>
            </a:extLst>
          </p:cNvPr>
          <p:cNvSpPr txBox="1"/>
          <p:nvPr/>
        </p:nvSpPr>
        <p:spPr>
          <a:xfrm>
            <a:off x="4934140" y="9598223"/>
            <a:ext cx="1923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B2FB4F9-78A7-2F98-AF65-D760DA5400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400" y="0"/>
            <a:ext cx="5417199" cy="94765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1129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1EE9C2DF-84CD-BC14-F144-E8E6EE22C3E0}"/>
              </a:ext>
            </a:extLst>
          </p:cNvPr>
          <p:cNvSpPr txBox="1"/>
          <p:nvPr/>
        </p:nvSpPr>
        <p:spPr>
          <a:xfrm>
            <a:off x="138546" y="143770"/>
            <a:ext cx="5907213" cy="20095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2. Phenotype assay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WB validated the relative protein level of NSUN2 in vector and shNSUN2 cell lines. Tukey HSD test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dU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ssay for vector and shNSUN2. Nuclei were stained with DAPI (blue).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dU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red) indicates cell viability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of vector and shNSUN2 cell migration and invasion assessed by in vitro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well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ssay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of colony formation for vector and shNSUN2.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E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of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dU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ssay for vector and NSUN2-OE. Nuclei were stained with DAPI (blue).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dU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red) indicates cell viability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of vector and NSUN2-OE cell migration and invasion assessed by in vitro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answell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ssay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of colony formation for vector and N-OE. Tukey HSD test.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83734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E68FAE0-A4EF-DDCF-C6BE-01EC02EBFD9F}"/>
              </a:ext>
            </a:extLst>
          </p:cNvPr>
          <p:cNvSpPr txBox="1"/>
          <p:nvPr/>
        </p:nvSpPr>
        <p:spPr>
          <a:xfrm>
            <a:off x="4934140" y="9598223"/>
            <a:ext cx="1923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EE494C9-5FE8-84E2-0F7D-0075B9A61E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706" y="0"/>
            <a:ext cx="5827716" cy="95982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81023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4539F92B-D17E-8E64-F86E-7D19693B070D}"/>
              </a:ext>
            </a:extLst>
          </p:cNvPr>
          <p:cNvSpPr txBox="1"/>
          <p:nvPr/>
        </p:nvSpPr>
        <p:spPr>
          <a:xfrm>
            <a:off x="173577" y="102930"/>
            <a:ext cx="6510846" cy="31598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3. Animal assay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Tumor weights of xenograft tumors harvested from NSUN2 knockdown and control KHM-5M injected mice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Tumor volumes of xenograft tumors harvested from NSUN2 knockdown and control KHM-5M injected mice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Hematoxylin-eosin staining and IHC staining of NSUN2 and Ki67 in tumors samples in xenograft mice model subcutaneously implanted with NSUN2 knockdown and control KHM-5M cells. Scale bars, 200 µm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of E-cadherin, p-ERK and PI3K IHC staining in tumors samples in xenograft mice model subcutaneously implanted with NSUN2 knockdown and control KHM-5M cells. Scale bars, 200 µm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Hematoxylin-eosin staining and IHC staining of NSUN2 and Ki67 in lung-metastatic nodules in model intracardiac-injected with NSUN2 knockdown and control KHM-5M cells. Scale bars, 200 µm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Cisplatin- or doxorubicin HCl-treated tumor weights of xenograft tumors harvested from NSUN2 knockdown and control KHM-5M injected mice. 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Cisplatin- or doxorubicin HCl-treated tumor volumes of xenograft tumors harvested from NSUN2 knockdown and control KHM-5M injected mice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presentative images of IHC staining of drug-treated tumors in xenograft mice model subcutaneously implanted with NSUN2 knockdown and control KHM-5M cells. Scale bars, 200 µm.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57087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865818F-952C-61E9-CBA9-1DD7D7CAD108}"/>
              </a:ext>
            </a:extLst>
          </p:cNvPr>
          <p:cNvSpPr txBox="1"/>
          <p:nvPr/>
        </p:nvSpPr>
        <p:spPr>
          <a:xfrm>
            <a:off x="4934140" y="9598223"/>
            <a:ext cx="1923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DCC480C-4B30-8806-E0AE-6D93DDDF87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1644"/>
            <a:ext cx="6705600" cy="9467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47335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2C233180-6686-E91E-4196-EA4315219B1A}"/>
              </a:ext>
            </a:extLst>
          </p:cNvPr>
          <p:cNvSpPr txBox="1"/>
          <p:nvPr/>
        </p:nvSpPr>
        <p:spPr>
          <a:xfrm>
            <a:off x="152400" y="131981"/>
            <a:ext cx="6356526" cy="18178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ure 4. Profiling and sequencing 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Histogram showing changes in methylation rate at m</a:t>
            </a:r>
            <a:r>
              <a:rPr lang="en-US" altLang="zh-CN" sz="1246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 sites in tRNA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sodecoders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Column plot showing global m</a:t>
            </a:r>
            <a:r>
              <a:rPr lang="en-US" altLang="zh-CN" sz="1246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 decrease between vector and shNSUN2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Venn </a:t>
            </a:r>
            <a:r>
              <a:rPr lang="en-US" altLang="zh-CN" sz="1246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iagram showing differentially methylated tRNA and cytosine in 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RNA bisulfite sequencing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GO and KEGG enrichment analysis of significantly different expressed transcripts by mRNA sequencing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Pathway enrichment analysis of translation-downregulated genes by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ibo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seq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~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H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Melt curve of specific primers in tRNA charging assay (F), tRNA related fragments quantification (G) and full length tRNA quantification (H) by 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PCR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Comparison of full length tRNA and representative 3’tRF sequence. </a:t>
            </a:r>
            <a:r>
              <a:rPr lang="en-US" altLang="zh-CN" sz="1246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J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c-</a:t>
            </a:r>
            <a:r>
              <a:rPr lang="en-US" altLang="zh-CN" sz="1246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yc</a:t>
            </a:r>
            <a:r>
              <a:rPr lang="en-US" altLang="zh-CN" sz="1246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related cancer network from KEGG. </a:t>
            </a:r>
            <a:endParaRPr lang="zh-CN" altLang="zh-CN" sz="1246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04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719</Words>
  <Application>Microsoft Office PowerPoint</Application>
  <PresentationFormat>A4 纸张(210x297 毫米)</PresentationFormat>
  <Paragraphs>18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7" baseType="lpstr">
      <vt:lpstr>等线</vt:lpstr>
      <vt:lpstr>Arial</vt:lpstr>
      <vt:lpstr>Calibri</vt:lpstr>
      <vt:lpstr>Calibri Light</vt:lpstr>
      <vt:lpstr>Times New Roman</vt:lpstr>
      <vt:lpstr>Office 主题​​</vt:lpstr>
      <vt:lpstr>Supplemental figures and figure legend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 and figure legends</dc:title>
  <dc:creator>Li Peng</dc:creator>
  <cp:lastModifiedBy>Li Peng</cp:lastModifiedBy>
  <cp:revision>2</cp:revision>
  <dcterms:created xsi:type="dcterms:W3CDTF">2023-02-16T06:51:36Z</dcterms:created>
  <dcterms:modified xsi:type="dcterms:W3CDTF">2023-07-23T15:32:15Z</dcterms:modified>
</cp:coreProperties>
</file>